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062" autoAdjust="0"/>
  </p:normalViewPr>
  <p:slideViewPr>
    <p:cSldViewPr snapToGrid="0">
      <p:cViewPr varScale="1">
        <p:scale>
          <a:sx n="106" d="100"/>
          <a:sy n="106" d="100"/>
        </p:scale>
        <p:origin x="7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47104E-1B19-4D3C-8687-A4BF8323E2FB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4D6DC7-AE77-4733-8E49-8835743F9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4242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4D6DC7-AE77-4733-8E49-8835743F98D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8729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0418B2-6AAB-A964-3E7F-143CEA458B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83A86B-4E66-5138-5BCC-9C766122A2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6EFD0-124B-9B71-1D1A-58FCBE9BF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D53BA4-B1F0-D826-7CBD-C5A2570013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12987A-17F5-AA5A-0756-466C214FB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65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B0AB4F-4964-A04B-4250-4937678350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C69914-C25C-BECD-F025-3ADDE6617B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288ECD-D39B-8FE5-2E0C-CA85A8446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A0BAE7-BCAB-7820-BD0E-FA5071D10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3087B2-0381-FD67-C07D-DD182A3C2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036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BF787B-C3C7-A67E-F75F-4434021469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A2D067-9EB5-97EE-E973-28AB78F2DB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3ACBF1-CD5B-CAB9-90FF-CA0B2C76F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F2494-9774-B8C5-5EBE-C8D817817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598A58-D08B-1656-320E-D6F72F7CD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062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ED925-6BC3-9BD8-FB61-8072681E31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67DCC3-F149-ED1B-7DAF-4407970BA4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774144-1C51-4500-42E1-37200E08F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60EEC7-874D-2BE8-60A6-0B66E7360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0211F6-6EAB-ABFC-56D9-CABDB8130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352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27844-4715-7D9E-10AA-C90CAFC77E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D82EDC-040B-185E-2228-CC3683C47C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F880E-B78F-7A00-A744-25A4343BC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A93A2B-A949-BD49-DE16-284A171FC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E10918-CC08-D77A-805F-0213A71EC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136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AF6E79-F963-8982-2C9F-C8F570ED51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3183CC-4A24-8A5B-0A63-354AAEBA5A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5A8FDC-42F9-869F-A34C-97A3118D57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63D7F7-7F3E-85C7-EAF1-31B384F46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6B8517-7769-442C-624B-D0C36BB6D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8A38C4-0CF4-2905-57EE-938C1CAFE9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284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36A24-00E0-D3AD-9FDF-16501F971A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E4CF07-23DF-AEA5-5F6D-DD4093E97D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2C037F-4981-E0A7-C83F-80890E4AE8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76EB5B-6D9B-8334-63D6-76CDE86E81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DA9870-7A26-35AF-3437-B434F7C00A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1119A3-ECD3-EBFC-DC08-E90453EF3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1AB9F9E-3A68-BFC4-6DBB-ACBF7B648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5D3578-DA0D-32E6-98F6-3344656AF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611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9433CE-A4B6-4984-DAF6-E7904A882D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660D5E8-8AF9-6AA1-67EF-681723FEF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705B3E7-4486-DD6F-3F90-150B720CA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48287A-579F-CA15-E065-A93D9A1D5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526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247C1AA-4B2B-7CA4-C46D-84C940538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D903D72-8EB1-623A-FFAA-4905B448F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00BC7D-4535-37A7-8192-BDB76CC8A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983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2F8D96-EE8B-82B0-6128-825251BFFD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E44ACC-C613-FDC3-F553-4BCCE3C2D9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0A113E-BC6F-B956-EEB1-1C144482E6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90FC93-AAF8-6D4F-2CAF-96AC64243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40CEB9-FC9F-8542-F498-4AFB78A36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EA7426-C57A-1768-E6DF-600ADB001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642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5F7C98-F093-2994-03D6-86E1CA9C8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32622D-0F3C-2F39-8823-A875696D51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CAB601-066D-C4F1-1E75-EEFF4B7DAF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437C9F-BBF8-6CD1-FE52-56E9DA48DB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D200B5-706C-0B4E-AB7A-F83847FD7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900EA6-C711-8A62-4E38-FFDABD510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388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E319BF-1C32-C508-A72B-81BE0C07FE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E65B12-760E-5D3D-D713-FAA748247B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7CA9C6-E307-86AA-B4B0-CCC581CE4C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E55528-4EAA-9844-A01D-327F4C8EE4F2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3E7C5-251F-53BF-92EF-BE8E162A81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EDBFD5-6353-BCCE-78E7-F10702663A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ABC2A14-E16E-824C-B203-4FAC13C68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534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riangle isocèle 3"/>
          <p:cNvSpPr/>
          <p:nvPr/>
        </p:nvSpPr>
        <p:spPr>
          <a:xfrm rot="10800000">
            <a:off x="3766464" y="1009633"/>
            <a:ext cx="5500726" cy="442915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cxnSp>
        <p:nvCxnSpPr>
          <p:cNvPr id="7" name="Connecteur droit 6"/>
          <p:cNvCxnSpPr/>
          <p:nvPr/>
        </p:nvCxnSpPr>
        <p:spPr>
          <a:xfrm rot="10800000">
            <a:off x="4337968" y="1928802"/>
            <a:ext cx="4429156" cy="1588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riangle isocèle 13"/>
          <p:cNvSpPr>
            <a:spLocks noChangeAspect="1"/>
          </p:cNvSpPr>
          <p:nvPr/>
        </p:nvSpPr>
        <p:spPr>
          <a:xfrm rot="10800000">
            <a:off x="4233193" y="1754815"/>
            <a:ext cx="4575258" cy="3683974"/>
          </a:xfrm>
          <a:prstGeom prst="triangl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sp>
        <p:nvSpPr>
          <p:cNvPr id="15" name="ZoneTexte 14"/>
          <p:cNvSpPr txBox="1"/>
          <p:nvPr/>
        </p:nvSpPr>
        <p:spPr>
          <a:xfrm>
            <a:off x="4980911" y="1202810"/>
            <a:ext cx="1037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107,014 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7066634" y="588486"/>
            <a:ext cx="1099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noProof="0" dirty="0"/>
              <a:t>Patient 2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4645587" y="614612"/>
            <a:ext cx="1099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noProof="0" dirty="0"/>
              <a:t>Patient 1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7166914" y="1202810"/>
            <a:ext cx="1037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111,516 </a:t>
            </a:r>
          </a:p>
        </p:txBody>
      </p:sp>
      <p:sp>
        <p:nvSpPr>
          <p:cNvPr id="19" name="Triangle isocèle 18"/>
          <p:cNvSpPr>
            <a:spLocks noChangeAspect="1"/>
          </p:cNvSpPr>
          <p:nvPr/>
        </p:nvSpPr>
        <p:spPr>
          <a:xfrm rot="10800000">
            <a:off x="4689092" y="2500306"/>
            <a:ext cx="3649405" cy="2938482"/>
          </a:xfrm>
          <a:prstGeom prst="triangl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sp>
        <p:nvSpPr>
          <p:cNvPr id="21" name="ZoneTexte 20"/>
          <p:cNvSpPr txBox="1"/>
          <p:nvPr/>
        </p:nvSpPr>
        <p:spPr>
          <a:xfrm>
            <a:off x="1247906" y="1959720"/>
            <a:ext cx="3249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MAF ≤ 1% in </a:t>
            </a:r>
            <a:r>
              <a:rPr lang="en-GB" noProof="0" dirty="0" err="1"/>
              <a:t>GnomAD</a:t>
            </a:r>
            <a:r>
              <a:rPr lang="en-GB" noProof="0" dirty="0"/>
              <a:t> (v2.1.1)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5195225" y="1959720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18,483 </a:t>
            </a:r>
          </a:p>
        </p:txBody>
      </p:sp>
      <p:sp>
        <p:nvSpPr>
          <p:cNvPr id="25" name="Triangle isocèle 24"/>
          <p:cNvSpPr>
            <a:spLocks noChangeAspect="1"/>
          </p:cNvSpPr>
          <p:nvPr/>
        </p:nvSpPr>
        <p:spPr>
          <a:xfrm rot="10800000">
            <a:off x="5119026" y="3188832"/>
            <a:ext cx="2805131" cy="2258677"/>
          </a:xfrm>
          <a:prstGeom prst="triangl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sp>
        <p:nvSpPr>
          <p:cNvPr id="26" name="ZoneTexte 25"/>
          <p:cNvSpPr txBox="1"/>
          <p:nvPr/>
        </p:nvSpPr>
        <p:spPr>
          <a:xfrm>
            <a:off x="5480976" y="2714620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2,683 </a:t>
            </a:r>
          </a:p>
        </p:txBody>
      </p:sp>
      <p:sp>
        <p:nvSpPr>
          <p:cNvPr id="28" name="Triangle isocèle 27"/>
          <p:cNvSpPr>
            <a:spLocks noChangeAspect="1"/>
          </p:cNvSpPr>
          <p:nvPr/>
        </p:nvSpPr>
        <p:spPr>
          <a:xfrm rot="10800000">
            <a:off x="5500026" y="3786190"/>
            <a:ext cx="2047659" cy="1648764"/>
          </a:xfrm>
          <a:prstGeom prst="triangle">
            <a:avLst/>
          </a:prstGeom>
          <a:solidFill>
            <a:schemeClr val="accent4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sp>
        <p:nvSpPr>
          <p:cNvPr id="20" name="ZoneTexte 19"/>
          <p:cNvSpPr txBox="1"/>
          <p:nvPr/>
        </p:nvSpPr>
        <p:spPr>
          <a:xfrm>
            <a:off x="5766728" y="3357562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90  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5823457" y="3929066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noProof="0" dirty="0"/>
              <a:t>71  </a:t>
            </a:r>
          </a:p>
        </p:txBody>
      </p:sp>
      <p:sp>
        <p:nvSpPr>
          <p:cNvPr id="30" name="ZoneTexte 29"/>
          <p:cNvSpPr txBox="1"/>
          <p:nvPr/>
        </p:nvSpPr>
        <p:spPr>
          <a:xfrm>
            <a:off x="6590646" y="449104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0</a:t>
            </a:r>
          </a:p>
        </p:txBody>
      </p:sp>
      <p:sp>
        <p:nvSpPr>
          <p:cNvPr id="34" name="Triangle isocèle 33"/>
          <p:cNvSpPr>
            <a:spLocks noChangeAspect="1"/>
          </p:cNvSpPr>
          <p:nvPr/>
        </p:nvSpPr>
        <p:spPr>
          <a:xfrm rot="10800000">
            <a:off x="5861981" y="4398517"/>
            <a:ext cx="1304933" cy="1050725"/>
          </a:xfrm>
          <a:prstGeom prst="triangle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cxnSp>
        <p:nvCxnSpPr>
          <p:cNvPr id="6" name="Connecteur droit 5"/>
          <p:cNvCxnSpPr>
            <a:cxnSpLocks/>
            <a:stCxn id="4" idx="3"/>
            <a:endCxn id="34" idx="3"/>
          </p:cNvCxnSpPr>
          <p:nvPr/>
        </p:nvCxnSpPr>
        <p:spPr>
          <a:xfrm flipH="1">
            <a:off x="6514447" y="1009633"/>
            <a:ext cx="2380" cy="338888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1" name="Triangle isocèle 30"/>
          <p:cNvSpPr>
            <a:spLocks noChangeAspect="1"/>
          </p:cNvSpPr>
          <p:nvPr/>
        </p:nvSpPr>
        <p:spPr>
          <a:xfrm rot="10800000">
            <a:off x="6162018" y="4857761"/>
            <a:ext cx="723906" cy="582885"/>
          </a:xfrm>
          <a:prstGeom prst="triangl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sp>
        <p:nvSpPr>
          <p:cNvPr id="32" name="ZoneTexte 31"/>
          <p:cNvSpPr txBox="1"/>
          <p:nvPr/>
        </p:nvSpPr>
        <p:spPr>
          <a:xfrm>
            <a:off x="6309395" y="4877203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10  </a:t>
            </a:r>
          </a:p>
        </p:txBody>
      </p:sp>
      <p:sp>
        <p:nvSpPr>
          <p:cNvPr id="36" name="ZoneTexte 35"/>
          <p:cNvSpPr txBox="1"/>
          <p:nvPr/>
        </p:nvSpPr>
        <p:spPr>
          <a:xfrm>
            <a:off x="6688898" y="3917361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7 </a:t>
            </a:r>
            <a:endParaRPr lang="en-GB" noProof="0" dirty="0"/>
          </a:p>
        </p:txBody>
      </p:sp>
      <p:sp>
        <p:nvSpPr>
          <p:cNvPr id="37" name="ZoneTexte 36"/>
          <p:cNvSpPr txBox="1"/>
          <p:nvPr/>
        </p:nvSpPr>
        <p:spPr>
          <a:xfrm>
            <a:off x="7159256" y="1959720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18,682 </a:t>
            </a:r>
          </a:p>
        </p:txBody>
      </p:sp>
      <p:sp>
        <p:nvSpPr>
          <p:cNvPr id="38" name="ZoneTexte 37"/>
          <p:cNvSpPr txBox="1"/>
          <p:nvPr/>
        </p:nvSpPr>
        <p:spPr>
          <a:xfrm>
            <a:off x="6981175" y="2712228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2,659 </a:t>
            </a:r>
          </a:p>
        </p:txBody>
      </p:sp>
      <p:sp>
        <p:nvSpPr>
          <p:cNvPr id="39" name="ZoneTexte 38"/>
          <p:cNvSpPr txBox="1"/>
          <p:nvPr/>
        </p:nvSpPr>
        <p:spPr>
          <a:xfrm>
            <a:off x="6909736" y="3357562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64 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3244037" y="3917361"/>
            <a:ext cx="2082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In-house MAF ≤ 5%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2639005" y="4495014"/>
            <a:ext cx="31541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noProof="0" dirty="0"/>
              <a:t>Found in both siblings</a:t>
            </a:r>
          </a:p>
        </p:txBody>
      </p:sp>
      <p:sp>
        <p:nvSpPr>
          <p:cNvPr id="47" name="ZoneTexte 46"/>
          <p:cNvSpPr txBox="1"/>
          <p:nvPr/>
        </p:nvSpPr>
        <p:spPr>
          <a:xfrm>
            <a:off x="6224468" y="4457473"/>
            <a:ext cx="523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19  </a:t>
            </a:r>
            <a:endParaRPr lang="en-GB" noProof="0" dirty="0"/>
          </a:p>
        </p:txBody>
      </p:sp>
      <p:sp>
        <p:nvSpPr>
          <p:cNvPr id="49" name="ZoneTexte 48"/>
          <p:cNvSpPr txBox="1"/>
          <p:nvPr/>
        </p:nvSpPr>
        <p:spPr>
          <a:xfrm>
            <a:off x="332016" y="189261"/>
            <a:ext cx="2780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1 </a:t>
            </a:r>
            <a:endParaRPr lang="en-GB" b="1" noProof="0" dirty="0"/>
          </a:p>
        </p:txBody>
      </p:sp>
      <p:sp>
        <p:nvSpPr>
          <p:cNvPr id="2" name="ZoneTexte 20">
            <a:extLst>
              <a:ext uri="{FF2B5EF4-FFF2-40B4-BE49-F238E27FC236}">
                <a16:creationId xmlns:a16="http://schemas.microsoft.com/office/drawing/2014/main" id="{DE8FAC8E-734A-E181-40C7-28F02F9F3451}"/>
              </a:ext>
            </a:extLst>
          </p:cNvPr>
          <p:cNvSpPr txBox="1"/>
          <p:nvPr/>
        </p:nvSpPr>
        <p:spPr>
          <a:xfrm>
            <a:off x="2200778" y="1202810"/>
            <a:ext cx="1775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ad depth &gt; 5</a:t>
            </a:r>
            <a:endParaRPr lang="en-GB" noProof="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E990F2C-594C-650E-87AA-0952324A2465}"/>
              </a:ext>
            </a:extLst>
          </p:cNvPr>
          <p:cNvSpPr txBox="1"/>
          <p:nvPr/>
        </p:nvSpPr>
        <p:spPr>
          <a:xfrm>
            <a:off x="1012373" y="2586672"/>
            <a:ext cx="395262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High or moderate impact on protein function (e.g., MS, FS, NFS, SS, NS)</a:t>
            </a:r>
          </a:p>
        </p:txBody>
      </p:sp>
      <p:sp>
        <p:nvSpPr>
          <p:cNvPr id="9" name="ZoneTexte 39">
            <a:extLst>
              <a:ext uri="{FF2B5EF4-FFF2-40B4-BE49-F238E27FC236}">
                <a16:creationId xmlns:a16="http://schemas.microsoft.com/office/drawing/2014/main" id="{41B9A825-2CC1-E83D-36CA-2535C8E750E7}"/>
              </a:ext>
            </a:extLst>
          </p:cNvPr>
          <p:cNvSpPr txBox="1"/>
          <p:nvPr/>
        </p:nvSpPr>
        <p:spPr>
          <a:xfrm>
            <a:off x="3533417" y="3347446"/>
            <a:ext cx="1430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Homozygote</a:t>
            </a:r>
          </a:p>
        </p:txBody>
      </p:sp>
      <p:sp>
        <p:nvSpPr>
          <p:cNvPr id="5" name="ZoneTexte 40">
            <a:extLst>
              <a:ext uri="{FF2B5EF4-FFF2-40B4-BE49-F238E27FC236}">
                <a16:creationId xmlns:a16="http://schemas.microsoft.com/office/drawing/2014/main" id="{E1DF2DF6-C014-3E82-E5C5-26CFDD1B23A4}"/>
              </a:ext>
            </a:extLst>
          </p:cNvPr>
          <p:cNvSpPr txBox="1"/>
          <p:nvPr/>
        </p:nvSpPr>
        <p:spPr>
          <a:xfrm>
            <a:off x="2213576" y="4934031"/>
            <a:ext cx="4128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lassified as not benign or likely benign</a:t>
            </a:r>
            <a:endParaRPr lang="en-GB" noProof="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E41F558-7A9C-35B9-3E1C-FBC596EE7C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948460"/>
              </p:ext>
            </p:extLst>
          </p:nvPr>
        </p:nvGraphicFramePr>
        <p:xfrm>
          <a:off x="332016" y="1188688"/>
          <a:ext cx="11583384" cy="3792702"/>
        </p:xfrm>
        <a:graphic>
          <a:graphicData uri="http://schemas.openxmlformats.org/drawingml/2006/table">
            <a:tbl>
              <a:tblPr/>
              <a:tblGrid>
                <a:gridCol w="607752">
                  <a:extLst>
                    <a:ext uri="{9D8B030D-6E8A-4147-A177-3AD203B41FA5}">
                      <a16:colId xmlns:a16="http://schemas.microsoft.com/office/drawing/2014/main" val="2176159776"/>
                    </a:ext>
                  </a:extLst>
                </a:gridCol>
                <a:gridCol w="1077652">
                  <a:extLst>
                    <a:ext uri="{9D8B030D-6E8A-4147-A177-3AD203B41FA5}">
                      <a16:colId xmlns:a16="http://schemas.microsoft.com/office/drawing/2014/main" val="4051187961"/>
                    </a:ext>
                  </a:extLst>
                </a:gridCol>
                <a:gridCol w="756977">
                  <a:extLst>
                    <a:ext uri="{9D8B030D-6E8A-4147-A177-3AD203B41FA5}">
                      <a16:colId xmlns:a16="http://schemas.microsoft.com/office/drawing/2014/main" val="3078758543"/>
                    </a:ext>
                  </a:extLst>
                </a:gridCol>
                <a:gridCol w="782377">
                  <a:extLst>
                    <a:ext uri="{9D8B030D-6E8A-4147-A177-3AD203B41FA5}">
                      <a16:colId xmlns:a16="http://schemas.microsoft.com/office/drawing/2014/main" val="1741894549"/>
                    </a:ext>
                  </a:extLst>
                </a:gridCol>
                <a:gridCol w="329940">
                  <a:extLst>
                    <a:ext uri="{9D8B030D-6E8A-4147-A177-3AD203B41FA5}">
                      <a16:colId xmlns:a16="http://schemas.microsoft.com/office/drawing/2014/main" val="2929170217"/>
                    </a:ext>
                  </a:extLst>
                </a:gridCol>
                <a:gridCol w="830002">
                  <a:extLst>
                    <a:ext uri="{9D8B030D-6E8A-4147-A177-3AD203B41FA5}">
                      <a16:colId xmlns:a16="http://schemas.microsoft.com/office/drawing/2014/main" val="791158730"/>
                    </a:ext>
                  </a:extLst>
                </a:gridCol>
                <a:gridCol w="625215">
                  <a:extLst>
                    <a:ext uri="{9D8B030D-6E8A-4147-A177-3AD203B41FA5}">
                      <a16:colId xmlns:a16="http://schemas.microsoft.com/office/drawing/2014/main" val="3766173650"/>
                    </a:ext>
                  </a:extLst>
                </a:gridCol>
                <a:gridCol w="404552">
                  <a:extLst>
                    <a:ext uri="{9D8B030D-6E8A-4147-A177-3AD203B41FA5}">
                      <a16:colId xmlns:a16="http://schemas.microsoft.com/office/drawing/2014/main" val="452093676"/>
                    </a:ext>
                  </a:extLst>
                </a:gridCol>
                <a:gridCol w="1058602">
                  <a:extLst>
                    <a:ext uri="{9D8B030D-6E8A-4147-A177-3AD203B41FA5}">
                      <a16:colId xmlns:a16="http://schemas.microsoft.com/office/drawing/2014/main" val="2096271070"/>
                    </a:ext>
                  </a:extLst>
                </a:gridCol>
                <a:gridCol w="717440">
                  <a:extLst>
                    <a:ext uri="{9D8B030D-6E8A-4147-A177-3AD203B41FA5}">
                      <a16:colId xmlns:a16="http://schemas.microsoft.com/office/drawing/2014/main" val="3236412551"/>
                    </a:ext>
                  </a:extLst>
                </a:gridCol>
                <a:gridCol w="1034837">
                  <a:extLst>
                    <a:ext uri="{9D8B030D-6E8A-4147-A177-3AD203B41FA5}">
                      <a16:colId xmlns:a16="http://schemas.microsoft.com/office/drawing/2014/main" val="279516304"/>
                    </a:ext>
                  </a:extLst>
                </a:gridCol>
                <a:gridCol w="365260">
                  <a:extLst>
                    <a:ext uri="{9D8B030D-6E8A-4147-A177-3AD203B41FA5}">
                      <a16:colId xmlns:a16="http://schemas.microsoft.com/office/drawing/2014/main" val="285577642"/>
                    </a:ext>
                  </a:extLst>
                </a:gridCol>
                <a:gridCol w="706955">
                  <a:extLst>
                    <a:ext uri="{9D8B030D-6E8A-4147-A177-3AD203B41FA5}">
                      <a16:colId xmlns:a16="http://schemas.microsoft.com/office/drawing/2014/main" val="730267613"/>
                    </a:ext>
                  </a:extLst>
                </a:gridCol>
                <a:gridCol w="730521">
                  <a:extLst>
                    <a:ext uri="{9D8B030D-6E8A-4147-A177-3AD203B41FA5}">
                      <a16:colId xmlns:a16="http://schemas.microsoft.com/office/drawing/2014/main" val="2690723472"/>
                    </a:ext>
                  </a:extLst>
                </a:gridCol>
                <a:gridCol w="1555302">
                  <a:extLst>
                    <a:ext uri="{9D8B030D-6E8A-4147-A177-3AD203B41FA5}">
                      <a16:colId xmlns:a16="http://schemas.microsoft.com/office/drawing/2014/main" val="3292268063"/>
                    </a:ext>
                  </a:extLst>
                </a:gridCol>
              </a:tblGrid>
              <a:tr h="3440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cript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 Chang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cleotid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n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ion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ffect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pth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omAD (Exome)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omAD (Genome)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FT Pred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FT Scor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YPHEN2 Pred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YPHEN2 Scor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ociated Phenotype (Bassed on OMIM)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0758470"/>
                  </a:ext>
                </a:extLst>
              </a:tr>
              <a:tr h="3440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AP4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5145.7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Trp141Arg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421T&gt;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nic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2E-06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eterious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eterious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9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rmatogenic failure 19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5591338"/>
                  </a:ext>
                </a:extLst>
              </a:tr>
              <a:tr h="3440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3K1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001671.4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Tyr663*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989T&gt;G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nic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op Gain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known phenotyp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6766039"/>
                  </a:ext>
                </a:extLst>
              </a:tr>
              <a:tr h="6880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L4B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079872.2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His255Tyr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763C&gt;T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nic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E-0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ertain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llectual developmental disorder, X-linked syndromic, Cabezas type 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526156"/>
                  </a:ext>
                </a:extLst>
              </a:tr>
              <a:tr h="3440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TR1B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0863.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Ile225Thr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674T&gt;C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nic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07026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274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ertain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ertain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known phenotyp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8226434"/>
                  </a:ext>
                </a:extLst>
              </a:tr>
              <a:tr h="1720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3GAT2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80742.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Gln94Arg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281A&gt;G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nic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ertain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known phenotyp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6839983"/>
                  </a:ext>
                </a:extLst>
              </a:tr>
              <a:tr h="3440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BP1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3392.4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143-6G&gt;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lice Region 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known 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57E-0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8E-0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known phenotyp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0542201"/>
                  </a:ext>
                </a:extLst>
              </a:tr>
              <a:tr h="3440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B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3388.6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Ala59Val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76C&gt;T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nic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9E-0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eterious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eterious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1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known phenotyp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287755"/>
                  </a:ext>
                </a:extLst>
              </a:tr>
              <a:tr h="1720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NF534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143938.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Pro577His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730C&gt;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nic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ertain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6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known phenotyp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1199482"/>
                  </a:ext>
                </a:extLst>
              </a:tr>
              <a:tr h="3440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S1P1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_003276.2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.96-6A&gt;G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lice Region 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known 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429248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known phenotyp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2680117"/>
                  </a:ext>
                </a:extLst>
              </a:tr>
              <a:tr h="3440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X12P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_033399.1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.1076-8C&gt;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lice Region 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known 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465386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known phenotype</a:t>
                      </a:r>
                    </a:p>
                  </a:txBody>
                  <a:tcPr marL="8601" marR="8601" marT="86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4955931"/>
                  </a:ext>
                </a:extLst>
              </a:tr>
            </a:tbl>
          </a:graphicData>
        </a:graphic>
      </p:graphicFrame>
      <p:sp>
        <p:nvSpPr>
          <p:cNvPr id="2" name="ZoneTexte 48">
            <a:extLst>
              <a:ext uri="{FF2B5EF4-FFF2-40B4-BE49-F238E27FC236}">
                <a16:creationId xmlns:a16="http://schemas.microsoft.com/office/drawing/2014/main" id="{D9D3F9BC-E7D3-658B-B998-3A2D582C0A2B}"/>
              </a:ext>
            </a:extLst>
          </p:cNvPr>
          <p:cNvSpPr txBox="1"/>
          <p:nvPr/>
        </p:nvSpPr>
        <p:spPr>
          <a:xfrm>
            <a:off x="332016" y="189261"/>
            <a:ext cx="2621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Table 1 </a:t>
            </a:r>
            <a:endParaRPr lang="en-GB" b="1" noProof="0" dirty="0"/>
          </a:p>
        </p:txBody>
      </p:sp>
    </p:spTree>
    <p:extLst>
      <p:ext uri="{BB962C8B-B14F-4D97-AF65-F5344CB8AC3E}">
        <p14:creationId xmlns:p14="http://schemas.microsoft.com/office/powerpoint/2010/main" val="1443645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435</Words>
  <Application>Microsoft Macintosh PowerPoint</Application>
  <PresentationFormat>Widescreen</PresentationFormat>
  <Paragraphs>19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wad, Fawaz</dc:creator>
  <cp:lastModifiedBy>Awad, Fawaz</cp:lastModifiedBy>
  <cp:revision>13</cp:revision>
  <dcterms:created xsi:type="dcterms:W3CDTF">2024-11-11T03:19:17Z</dcterms:created>
  <dcterms:modified xsi:type="dcterms:W3CDTF">2024-11-12T19:46:25Z</dcterms:modified>
</cp:coreProperties>
</file>